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6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74788" y="1162050"/>
            <a:ext cx="40608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atmap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how similar information, except that these show the expression in both humanized and non-humanized sampl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22A78B4-7EA9-4D98-9F86-E18775CE8DC1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672934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304859" y="608222"/>
            <a:ext cx="34486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11</a:t>
            </a:r>
          </a:p>
        </p:txBody>
      </p:sp>
      <p:grpSp>
        <p:nvGrpSpPr>
          <p:cNvPr id="15" name="Group 14"/>
          <p:cNvGrpSpPr/>
          <p:nvPr/>
        </p:nvGrpSpPr>
        <p:grpSpPr>
          <a:xfrm>
            <a:off x="105129" y="1622363"/>
            <a:ext cx="10015268" cy="4533037"/>
            <a:chOff x="352779" y="1622363"/>
            <a:chExt cx="10015268" cy="4533037"/>
          </a:xfrm>
        </p:grpSpPr>
        <p:sp>
          <p:nvSpPr>
            <p:cNvPr id="6" name="TextBox 5"/>
            <p:cNvSpPr txBox="1"/>
            <p:nvPr/>
          </p:nvSpPr>
          <p:spPr>
            <a:xfrm>
              <a:off x="767257" y="1622363"/>
              <a:ext cx="40885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Intestine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876800" y="1626130"/>
              <a:ext cx="40569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BSGW </a:t>
              </a: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Intestine</a:t>
              </a: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352779" y="1881352"/>
              <a:ext cx="10015268" cy="4274048"/>
              <a:chOff x="352779" y="1881352"/>
              <a:chExt cx="10015268" cy="4274048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352779" y="1881352"/>
                <a:ext cx="9409881" cy="4274048"/>
                <a:chOff x="352779" y="1881352"/>
                <a:chExt cx="9409881" cy="4274048"/>
              </a:xfrm>
            </p:grpSpPr>
            <p:grpSp>
              <p:nvGrpSpPr>
                <p:cNvPr id="3" name="Group 2"/>
                <p:cNvGrpSpPr/>
                <p:nvPr/>
              </p:nvGrpSpPr>
              <p:grpSpPr>
                <a:xfrm>
                  <a:off x="352779" y="1881352"/>
                  <a:ext cx="9088677" cy="4274048"/>
                  <a:chOff x="352779" y="1881352"/>
                  <a:chExt cx="9088677" cy="4274048"/>
                </a:xfrm>
              </p:grpSpPr>
              <p:pic>
                <p:nvPicPr>
                  <p:cNvPr id="4" name="Picture 3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3408" r="6781" b="7141"/>
                  <a:stretch/>
                </p:blipFill>
                <p:spPr>
                  <a:xfrm>
                    <a:off x="352779" y="1881352"/>
                    <a:ext cx="8915162" cy="4274048"/>
                  </a:xfrm>
                  <a:prstGeom prst="rect">
                    <a:avLst/>
                  </a:prstGeom>
                </p:spPr>
              </p:pic>
              <p:sp>
                <p:nvSpPr>
                  <p:cNvPr id="2" name="Rectangle 1"/>
                  <p:cNvSpPr/>
                  <p:nvPr/>
                </p:nvSpPr>
                <p:spPr>
                  <a:xfrm>
                    <a:off x="9039340" y="3059935"/>
                    <a:ext cx="347031" cy="15423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8" name="Rectangle 7"/>
                  <p:cNvSpPr/>
                  <p:nvPr/>
                </p:nvSpPr>
                <p:spPr>
                  <a:xfrm>
                    <a:off x="9094425" y="4132244"/>
                    <a:ext cx="347031" cy="15423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marL="0" marR="0" lvl="0" indent="0" algn="ctr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US" sz="1800" b="0" i="0" u="none" strike="noStrike" kern="120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</p:grpSp>
            <p:sp>
              <p:nvSpPr>
                <p:cNvPr id="9" name="TextBox 8"/>
                <p:cNvSpPr txBox="1"/>
                <p:nvPr/>
              </p:nvSpPr>
              <p:spPr>
                <a:xfrm>
                  <a:off x="9007325" y="3027145"/>
                  <a:ext cx="75533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Expression</a:t>
                  </a:r>
                  <a:endPara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9186729" y="3214171"/>
                  <a:ext cx="287258" cy="7848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2</a:t>
                  </a:r>
                </a:p>
                <a:p>
                  <a:pPr marL="0" marR="0" lvl="0" indent="0" algn="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1</a:t>
                  </a:r>
                </a:p>
                <a:p>
                  <a:pPr marL="0" marR="0" lvl="0" indent="0" algn="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0</a:t>
                  </a:r>
                </a:p>
                <a:p>
                  <a:pPr marL="0" marR="0" lvl="0" indent="0" algn="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-1</a:t>
                  </a:r>
                </a:p>
                <a:p>
                  <a:pPr marL="0" marR="0" lvl="0" indent="0" algn="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9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-2</a:t>
                  </a:r>
                  <a:endParaRPr kumimoji="0" lang="en-US" sz="9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" name="TextBox 11"/>
              <p:cNvSpPr txBox="1"/>
              <p:nvPr/>
            </p:nvSpPr>
            <p:spPr>
              <a:xfrm>
                <a:off x="9052076" y="4093946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dentity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9138223" y="4235057"/>
                <a:ext cx="12298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HuNBSGW</a:t>
                </a: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intestine</a:t>
                </a:r>
              </a:p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NBSGW intestine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025695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40</Words>
  <Application>Microsoft Office PowerPoint</Application>
  <PresentationFormat>Custom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24</cp:revision>
  <dcterms:created xsi:type="dcterms:W3CDTF">2024-11-19T17:14:58Z</dcterms:created>
  <dcterms:modified xsi:type="dcterms:W3CDTF">2024-11-19T17:49:17Z</dcterms:modified>
</cp:coreProperties>
</file>